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3534" y="18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ED591-FD9B-8FC3-C612-F507D5037A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19420A0-C94B-D9D4-0EA0-D6FFCEF8AD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8E936-D96B-B8AE-15B2-7FB618D47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83C2F2-9141-11B5-3153-DA2305646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7C0AF9-71B2-D166-1FDD-AC446C37C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580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859E64-A5F5-5D35-32A2-C95CB8CB4A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6FA816-3031-D1F2-F33E-F9D7748D72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C9705E-5A7D-7F41-5121-6D2244B89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1D6059-30F7-BA1E-2BB4-5057E2F77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29CEF3-6E1E-889C-39A9-02908922B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8159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D492A4-25C2-76E7-F88F-07E8283707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B16705-D404-25A2-2FCD-F935C8BE38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14DED8-B9F7-03B9-6A9E-E3B98E3D1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19C37F-F189-8468-114E-CD4C86ECA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42FFAC-9720-E190-9F0E-3FEE29D8C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1994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BFBBE4-F7C2-E863-7513-689F58A98B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17FEAE-AA72-9E3F-A591-7EDBBABF4E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F8995F-0566-0557-C951-C91C2E45C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E6651F-EB90-50A0-D8B8-A606C35B2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AFD91B-97CC-9626-375B-BFBF70484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504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4E501-1E3D-882B-893F-384B419991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DA5913-190A-3C9F-8FDC-6A54DE106B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400353-0891-081A-00E6-E92757113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758761-6EFA-1EB6-EF14-D49124881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E23F32-6BA5-7B69-5338-4020F5D354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97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8696B-2498-2010-5DB4-8B26BF31A4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C7832A-56E0-F99D-3896-325B580B83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302765-7C0F-FD0F-F5AC-D201305F19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5BCD35-30EF-D950-DE37-C68E7F264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5F3253-3BE5-567A-D31F-7D7387F0D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0AD819-C792-4C87-B747-546374AD2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3999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C7A267-0109-2535-845A-93B5E5A16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01F641-FCE5-ECAF-454B-3B64C4FA2F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2C96B1-2576-7F04-98C1-47E0A55F3C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7155F9-783E-879E-E404-D388AB5464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13CBBE-7504-4C28-DB13-CBAE95E8A3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CF031E-BC87-24FC-A6A4-2A977EFEB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549FA36-2C70-1D83-4BAB-21FC14CD2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BCC6D71-9AA1-8961-F795-616393AE3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1119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EA3494-EC7A-720C-7AB3-708C6412AE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CB1A51-8C54-80BB-0220-1925B78D4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CED338-8B53-61BF-D842-D3D24EDA5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BC6B24-9D18-748A-5954-357EF5CBC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5835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DA7CE0-7D28-D79B-0A65-AEB25D4CA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241C29A-989A-7B07-9230-D05325931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97D022-DCCB-1D7A-C652-E5931E9BE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274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54DC25-6BB6-E641-F0D7-DABE4FB27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8C5377-B721-3193-7969-8CEDBAF1C7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64DD77-2828-1A1D-9972-EB8632C8A8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3813B6-450C-34AA-93E0-4589BF89D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26F0C0-5E45-1274-2B83-BF71395BB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511176-9435-10A0-69F8-5033B5759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7905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E19477-B740-6D25-DAED-3403A37DD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FDF75F-573F-4ADF-CA6C-AF3E6CC369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316A10-0980-71C8-3453-53F48E2CAD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A3F431-6F63-2C9D-FBC7-E66596406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61106C-C02E-FFEB-DE5F-A847192B1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B8E2D1-7448-12F5-4042-0298C72F7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380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6553AA-4236-4F10-BB96-346A8464E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3F3C93-3E21-647A-C88B-C3A8339F8B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C29A6B-3A42-14F9-1387-952F1172ED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F7EA52-E418-4022-9F5A-9379ABC97752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DE9AE4-C254-4FB8-5CDA-3D927800BA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467D06-8FA9-20E2-6C5E-136463018B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672B78-9952-403E-8764-CBFA5B4146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304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>
            <a:extLst>
              <a:ext uri="{FF2B5EF4-FFF2-40B4-BE49-F238E27FC236}">
                <a16:creationId xmlns:a16="http://schemas.microsoft.com/office/drawing/2014/main" id="{0207F0C0-8D16-2424-97CE-4E570ACE193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672" t="17304" r="34891" b="58623"/>
          <a:stretch/>
        </p:blipFill>
        <p:spPr>
          <a:xfrm rot="16200000">
            <a:off x="1384160" y="287611"/>
            <a:ext cx="319650" cy="16474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2483159-F76E-4600-65FD-323B952F772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56" t="17454" r="46872" b="58371"/>
          <a:stretch/>
        </p:blipFill>
        <p:spPr>
          <a:xfrm rot="16200000">
            <a:off x="1384160" y="1005629"/>
            <a:ext cx="319650" cy="16474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CC348C5-D2CF-82FB-E597-5141FF5AEDA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76" t="55231" r="57086" b="20764"/>
          <a:stretch/>
        </p:blipFill>
        <p:spPr>
          <a:xfrm rot="16200000">
            <a:off x="1384160" y="646620"/>
            <a:ext cx="319650" cy="16474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1A815C3C-CB46-FCA8-F0F7-77C5C9FBD072}"/>
              </a:ext>
            </a:extLst>
          </p:cNvPr>
          <p:cNvSpPr txBox="1"/>
          <p:nvPr/>
        </p:nvSpPr>
        <p:spPr>
          <a:xfrm>
            <a:off x="2377467" y="1020781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922F56F-D99A-86AC-CECC-0F507ECE6E0A}"/>
              </a:ext>
            </a:extLst>
          </p:cNvPr>
          <p:cNvSpPr txBox="1"/>
          <p:nvPr/>
        </p:nvSpPr>
        <p:spPr>
          <a:xfrm>
            <a:off x="348138" y="1733166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F289118-B670-24F3-FF3B-41298574DAF8}"/>
              </a:ext>
            </a:extLst>
          </p:cNvPr>
          <p:cNvSpPr txBox="1"/>
          <p:nvPr/>
        </p:nvSpPr>
        <p:spPr>
          <a:xfrm>
            <a:off x="2371298" y="1716640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BAE0F1A-3B47-571B-AC50-53D6D045BCDE}"/>
              </a:ext>
            </a:extLst>
          </p:cNvPr>
          <p:cNvSpPr txBox="1"/>
          <p:nvPr/>
        </p:nvSpPr>
        <p:spPr>
          <a:xfrm>
            <a:off x="701417" y="748156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C4A7029-865F-19EE-1761-198BE7D42519}"/>
              </a:ext>
            </a:extLst>
          </p:cNvPr>
          <p:cNvSpPr txBox="1"/>
          <p:nvPr/>
        </p:nvSpPr>
        <p:spPr>
          <a:xfrm>
            <a:off x="856203" y="748156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4C7BC96-2A11-22A9-71FC-550EF7C5A6E4}"/>
              </a:ext>
            </a:extLst>
          </p:cNvPr>
          <p:cNvSpPr txBox="1"/>
          <p:nvPr/>
        </p:nvSpPr>
        <p:spPr>
          <a:xfrm>
            <a:off x="1070003" y="748156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D64937C-3946-9B79-9E81-00701C86A837}"/>
              </a:ext>
            </a:extLst>
          </p:cNvPr>
          <p:cNvSpPr txBox="1"/>
          <p:nvPr/>
        </p:nvSpPr>
        <p:spPr>
          <a:xfrm>
            <a:off x="1283800" y="748156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B1C14997-763D-C58E-0B6B-91BB387B13CA}"/>
              </a:ext>
            </a:extLst>
          </p:cNvPr>
          <p:cNvCxnSpPr>
            <a:cxnSpLocks/>
          </p:cNvCxnSpPr>
          <p:nvPr/>
        </p:nvCxnSpPr>
        <p:spPr>
          <a:xfrm>
            <a:off x="767480" y="758337"/>
            <a:ext cx="6721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0D8D87D-F619-1458-296C-CB4BF27B64DB}"/>
              </a:ext>
            </a:extLst>
          </p:cNvPr>
          <p:cNvCxnSpPr>
            <a:cxnSpLocks/>
          </p:cNvCxnSpPr>
          <p:nvPr/>
        </p:nvCxnSpPr>
        <p:spPr>
          <a:xfrm>
            <a:off x="1590258" y="760595"/>
            <a:ext cx="6721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BF0565B6-9FB1-550E-84FE-D3EC01656B94}"/>
              </a:ext>
            </a:extLst>
          </p:cNvPr>
          <p:cNvSpPr txBox="1"/>
          <p:nvPr/>
        </p:nvSpPr>
        <p:spPr>
          <a:xfrm>
            <a:off x="1546935" y="546865"/>
            <a:ext cx="7393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A22EDB3-8C60-B6FA-AB55-6EC470B55858}"/>
              </a:ext>
            </a:extLst>
          </p:cNvPr>
          <p:cNvSpPr txBox="1"/>
          <p:nvPr/>
        </p:nvSpPr>
        <p:spPr>
          <a:xfrm>
            <a:off x="1497599" y="748156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6ED130A-6A34-BED5-B63A-CE7A9B4FFB92}"/>
              </a:ext>
            </a:extLst>
          </p:cNvPr>
          <p:cNvSpPr txBox="1"/>
          <p:nvPr/>
        </p:nvSpPr>
        <p:spPr>
          <a:xfrm>
            <a:off x="1652385" y="748156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57719E4-C63A-8DAA-ADC1-66DD5B756F1E}"/>
              </a:ext>
            </a:extLst>
          </p:cNvPr>
          <p:cNvSpPr txBox="1"/>
          <p:nvPr/>
        </p:nvSpPr>
        <p:spPr>
          <a:xfrm>
            <a:off x="1866184" y="748156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265F2B0-FE17-9455-4222-DA33E7AAAA9F}"/>
              </a:ext>
            </a:extLst>
          </p:cNvPr>
          <p:cNvSpPr txBox="1"/>
          <p:nvPr/>
        </p:nvSpPr>
        <p:spPr>
          <a:xfrm>
            <a:off x="2079982" y="748156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21C3945-01ED-CA6A-6491-B8960672D78C}"/>
              </a:ext>
            </a:extLst>
          </p:cNvPr>
          <p:cNvSpPr txBox="1"/>
          <p:nvPr/>
        </p:nvSpPr>
        <p:spPr>
          <a:xfrm>
            <a:off x="819348" y="553732"/>
            <a:ext cx="50596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92D5FB5-BC68-CEE5-A3F7-CE69C1995909}"/>
              </a:ext>
            </a:extLst>
          </p:cNvPr>
          <p:cNvSpPr txBox="1"/>
          <p:nvPr/>
        </p:nvSpPr>
        <p:spPr>
          <a:xfrm>
            <a:off x="294127" y="792352"/>
            <a:ext cx="35440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0AF939C-212E-C020-EF06-7F51B766A782}"/>
              </a:ext>
            </a:extLst>
          </p:cNvPr>
          <p:cNvSpPr txBox="1"/>
          <p:nvPr/>
        </p:nvSpPr>
        <p:spPr>
          <a:xfrm>
            <a:off x="2367699" y="1400330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9AAA11C-8EFD-E355-ECA4-40805149ACD0}"/>
              </a:ext>
            </a:extLst>
          </p:cNvPr>
          <p:cNvSpPr txBox="1"/>
          <p:nvPr/>
        </p:nvSpPr>
        <p:spPr>
          <a:xfrm>
            <a:off x="324796" y="1436272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4C1594E-8ADE-76FF-9B9B-DF4B5EAF552D}"/>
              </a:ext>
            </a:extLst>
          </p:cNvPr>
          <p:cNvSpPr txBox="1"/>
          <p:nvPr/>
        </p:nvSpPr>
        <p:spPr>
          <a:xfrm>
            <a:off x="294489" y="1025503"/>
            <a:ext cx="342751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C6F652D-2B04-4B05-B46E-A29576105D29}"/>
              </a:ext>
            </a:extLst>
          </p:cNvPr>
          <p:cNvSpPr txBox="1"/>
          <p:nvPr/>
        </p:nvSpPr>
        <p:spPr>
          <a:xfrm>
            <a:off x="2370307" y="727669"/>
            <a:ext cx="10530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min) 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E2E9FE6F-EB81-4EB0-B13A-F3CE8EE98F7B}"/>
              </a:ext>
            </a:extLst>
          </p:cNvPr>
          <p:cNvCxnSpPr/>
          <p:nvPr/>
        </p:nvCxnSpPr>
        <p:spPr>
          <a:xfrm>
            <a:off x="596582" y="1127971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14BBD8D0-C99B-DEC1-754C-4D0826E7A530}"/>
              </a:ext>
            </a:extLst>
          </p:cNvPr>
          <p:cNvCxnSpPr/>
          <p:nvPr/>
        </p:nvCxnSpPr>
        <p:spPr>
          <a:xfrm>
            <a:off x="596582" y="1526954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802CE2E7-F57E-83BA-93B2-8169630D90D6}"/>
              </a:ext>
            </a:extLst>
          </p:cNvPr>
          <p:cNvCxnSpPr/>
          <p:nvPr/>
        </p:nvCxnSpPr>
        <p:spPr>
          <a:xfrm>
            <a:off x="596582" y="1839077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457817EC-05D4-B63A-0C96-A5B53E396D57}"/>
              </a:ext>
            </a:extLst>
          </p:cNvPr>
          <p:cNvSpPr txBox="1"/>
          <p:nvPr/>
        </p:nvSpPr>
        <p:spPr>
          <a:xfrm>
            <a:off x="128573" y="48289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0C55FA6-EF4B-FCC4-4576-02BC813E7B93}"/>
              </a:ext>
            </a:extLst>
          </p:cNvPr>
          <p:cNvSpPr txBox="1"/>
          <p:nvPr/>
        </p:nvSpPr>
        <p:spPr>
          <a:xfrm>
            <a:off x="656987" y="1984432"/>
            <a:ext cx="16145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 - nuclear fraction</a:t>
            </a:r>
          </a:p>
        </p:txBody>
      </p:sp>
      <p:pic>
        <p:nvPicPr>
          <p:cNvPr id="60" name="Picture 59">
            <a:extLst>
              <a:ext uri="{FF2B5EF4-FFF2-40B4-BE49-F238E27FC236}">
                <a16:creationId xmlns:a16="http://schemas.microsoft.com/office/drawing/2014/main" id="{39C6EDB8-D442-0648-DAB1-03F1CEEC798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6" t="-630" r="-5" b="487"/>
          <a:stretch/>
        </p:blipFill>
        <p:spPr>
          <a:xfrm rot="16200000">
            <a:off x="736893" y="1863734"/>
            <a:ext cx="2787877" cy="38684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4BBCF65E-5CD3-F948-C4ED-00B8D5A06EB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9" t="876" r="-260" b="-70"/>
          <a:stretch/>
        </p:blipFill>
        <p:spPr>
          <a:xfrm rot="16200000">
            <a:off x="4663422" y="1861099"/>
            <a:ext cx="2788673" cy="38426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E20B8AF1-4B89-8E94-7777-9D4549CC952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0" t="922" r="1046" b="956"/>
          <a:stretch/>
        </p:blipFill>
        <p:spPr>
          <a:xfrm rot="16200000">
            <a:off x="8671805" y="1706485"/>
            <a:ext cx="2888532" cy="41518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Rectangle 62">
            <a:extLst>
              <a:ext uri="{FF2B5EF4-FFF2-40B4-BE49-F238E27FC236}">
                <a16:creationId xmlns:a16="http://schemas.microsoft.com/office/drawing/2014/main" id="{200C6A5E-B4A9-D09C-B570-E8774A49EB32}"/>
              </a:ext>
            </a:extLst>
          </p:cNvPr>
          <p:cNvSpPr/>
          <p:nvPr/>
        </p:nvSpPr>
        <p:spPr>
          <a:xfrm>
            <a:off x="767480" y="3352800"/>
            <a:ext cx="1169365" cy="205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BEB20630-A77F-E36B-1142-3571B1D8FE96}"/>
              </a:ext>
            </a:extLst>
          </p:cNvPr>
          <p:cNvSpPr/>
          <p:nvPr/>
        </p:nvSpPr>
        <p:spPr>
          <a:xfrm>
            <a:off x="6120508" y="3977640"/>
            <a:ext cx="1169365" cy="205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EE5AE080-8FEE-BEAC-B1E1-188490432CEE}"/>
              </a:ext>
            </a:extLst>
          </p:cNvPr>
          <p:cNvSpPr/>
          <p:nvPr/>
        </p:nvSpPr>
        <p:spPr>
          <a:xfrm>
            <a:off x="8635108" y="3679544"/>
            <a:ext cx="1169365" cy="205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819A149-2C3E-E759-4359-6707983308C2}"/>
              </a:ext>
            </a:extLst>
          </p:cNvPr>
          <p:cNvSpPr txBox="1"/>
          <p:nvPr/>
        </p:nvSpPr>
        <p:spPr>
          <a:xfrm>
            <a:off x="1963900" y="3324076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79A5975-162C-34FF-C33F-51A44545C966}"/>
              </a:ext>
            </a:extLst>
          </p:cNvPr>
          <p:cNvSpPr txBox="1"/>
          <p:nvPr/>
        </p:nvSpPr>
        <p:spPr>
          <a:xfrm>
            <a:off x="7350939" y="3979843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E3025FD-8C20-1A2B-8194-720D960CD610}"/>
              </a:ext>
            </a:extLst>
          </p:cNvPr>
          <p:cNvSpPr txBox="1"/>
          <p:nvPr/>
        </p:nvSpPr>
        <p:spPr>
          <a:xfrm>
            <a:off x="7956751" y="3666998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</p:spTree>
    <p:extLst>
      <p:ext uri="{BB962C8B-B14F-4D97-AF65-F5344CB8AC3E}">
        <p14:creationId xmlns:p14="http://schemas.microsoft.com/office/powerpoint/2010/main" val="30692509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94051CE-F408-B9E3-2426-7D9D3F31DD4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046" t="18526" r="68517" b="57401"/>
          <a:stretch/>
        </p:blipFill>
        <p:spPr>
          <a:xfrm rot="16200000">
            <a:off x="1402774" y="191475"/>
            <a:ext cx="319651" cy="16474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4208C13-27F7-4A0A-44AA-6AB395D25D3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01" t="19691" r="79827" b="56134"/>
          <a:stretch/>
        </p:blipFill>
        <p:spPr>
          <a:xfrm rot="16200000">
            <a:off x="1402774" y="909489"/>
            <a:ext cx="319651" cy="16474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1869E4D-B997-F4C1-354C-CABA012D227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19" t="55289" r="66143" b="20706"/>
          <a:stretch/>
        </p:blipFill>
        <p:spPr>
          <a:xfrm rot="16200000">
            <a:off x="1402774" y="550482"/>
            <a:ext cx="319651" cy="16474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82F00E5-02B2-31C0-66B6-CCE9FFD54C1C}"/>
              </a:ext>
            </a:extLst>
          </p:cNvPr>
          <p:cNvSpPr txBox="1"/>
          <p:nvPr/>
        </p:nvSpPr>
        <p:spPr>
          <a:xfrm>
            <a:off x="2409837" y="924645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C7DC787-DD94-4D8A-9D24-A60DC836DBA5}"/>
              </a:ext>
            </a:extLst>
          </p:cNvPr>
          <p:cNvSpPr txBox="1"/>
          <p:nvPr/>
        </p:nvSpPr>
        <p:spPr>
          <a:xfrm>
            <a:off x="378634" y="1633979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3B0EE63-8289-F665-BA87-60E7D02E7E60}"/>
              </a:ext>
            </a:extLst>
          </p:cNvPr>
          <p:cNvSpPr txBox="1"/>
          <p:nvPr/>
        </p:nvSpPr>
        <p:spPr>
          <a:xfrm>
            <a:off x="2403667" y="1620504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0DE6FDA-D798-7FA0-23FD-CC4978202569}"/>
              </a:ext>
            </a:extLst>
          </p:cNvPr>
          <p:cNvSpPr txBox="1"/>
          <p:nvPr/>
        </p:nvSpPr>
        <p:spPr>
          <a:xfrm>
            <a:off x="650572" y="1866269"/>
            <a:ext cx="16145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 - nuclear fract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9772D47-D9EB-D0E3-7510-25CC2055CB88}"/>
              </a:ext>
            </a:extLst>
          </p:cNvPr>
          <p:cNvSpPr txBox="1"/>
          <p:nvPr/>
        </p:nvSpPr>
        <p:spPr>
          <a:xfrm>
            <a:off x="725397" y="652020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469444A-E16C-BE30-72B0-CBBA517CF6DB}"/>
              </a:ext>
            </a:extLst>
          </p:cNvPr>
          <p:cNvSpPr txBox="1"/>
          <p:nvPr/>
        </p:nvSpPr>
        <p:spPr>
          <a:xfrm>
            <a:off x="880183" y="652020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E4358E-EA55-9766-5088-F1E663EF9CD0}"/>
              </a:ext>
            </a:extLst>
          </p:cNvPr>
          <p:cNvSpPr txBox="1"/>
          <p:nvPr/>
        </p:nvSpPr>
        <p:spPr>
          <a:xfrm>
            <a:off x="1093982" y="652020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5F33557-6BB0-A7FF-F7AB-1D9B19496573}"/>
              </a:ext>
            </a:extLst>
          </p:cNvPr>
          <p:cNvSpPr txBox="1"/>
          <p:nvPr/>
        </p:nvSpPr>
        <p:spPr>
          <a:xfrm>
            <a:off x="1307780" y="652020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761D81B-6832-03F9-04AD-B9A50B0135D8}"/>
              </a:ext>
            </a:extLst>
          </p:cNvPr>
          <p:cNvSpPr txBox="1"/>
          <p:nvPr/>
        </p:nvSpPr>
        <p:spPr>
          <a:xfrm>
            <a:off x="1591221" y="459510"/>
            <a:ext cx="6992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9BB0A2F-B29D-AEED-CB2D-474B2C5ADFF7}"/>
              </a:ext>
            </a:extLst>
          </p:cNvPr>
          <p:cNvSpPr txBox="1"/>
          <p:nvPr/>
        </p:nvSpPr>
        <p:spPr>
          <a:xfrm>
            <a:off x="1521579" y="652020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78F7B13-1E0B-CB20-8F76-FDCED34A7787}"/>
              </a:ext>
            </a:extLst>
          </p:cNvPr>
          <p:cNvSpPr txBox="1"/>
          <p:nvPr/>
        </p:nvSpPr>
        <p:spPr>
          <a:xfrm>
            <a:off x="1676365" y="652020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912AF9D-BAFE-8A5E-0FC6-7E2E61E0BE5C}"/>
              </a:ext>
            </a:extLst>
          </p:cNvPr>
          <p:cNvSpPr txBox="1"/>
          <p:nvPr/>
        </p:nvSpPr>
        <p:spPr>
          <a:xfrm>
            <a:off x="1890164" y="652020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8CE970B-F8E0-4C6F-B268-4D16624D372D}"/>
              </a:ext>
            </a:extLst>
          </p:cNvPr>
          <p:cNvSpPr txBox="1"/>
          <p:nvPr/>
        </p:nvSpPr>
        <p:spPr>
          <a:xfrm>
            <a:off x="2103962" y="652020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BBEA9E6-2ECA-B67B-D027-18CA7FE30CF9}"/>
              </a:ext>
            </a:extLst>
          </p:cNvPr>
          <p:cNvSpPr txBox="1"/>
          <p:nvPr/>
        </p:nvSpPr>
        <p:spPr>
          <a:xfrm>
            <a:off x="840291" y="468415"/>
            <a:ext cx="50596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1E01081-DC87-DB15-86D3-B14905B65F33}"/>
              </a:ext>
            </a:extLst>
          </p:cNvPr>
          <p:cNvSpPr txBox="1"/>
          <p:nvPr/>
        </p:nvSpPr>
        <p:spPr>
          <a:xfrm>
            <a:off x="333913" y="669078"/>
            <a:ext cx="485537" cy="209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95CF285-1D7C-A4B6-398B-DA3D18D6780A}"/>
              </a:ext>
            </a:extLst>
          </p:cNvPr>
          <p:cNvSpPr txBox="1"/>
          <p:nvPr/>
        </p:nvSpPr>
        <p:spPr>
          <a:xfrm>
            <a:off x="2400068" y="1304193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50C5081-D1A6-2E1C-5E6C-A897DE272BF6}"/>
              </a:ext>
            </a:extLst>
          </p:cNvPr>
          <p:cNvSpPr txBox="1"/>
          <p:nvPr/>
        </p:nvSpPr>
        <p:spPr>
          <a:xfrm>
            <a:off x="357164" y="1340136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A816BEF-6EBE-D1B0-1D2F-7F8109CF1743}"/>
              </a:ext>
            </a:extLst>
          </p:cNvPr>
          <p:cNvSpPr txBox="1"/>
          <p:nvPr/>
        </p:nvSpPr>
        <p:spPr>
          <a:xfrm>
            <a:off x="326857" y="929367"/>
            <a:ext cx="342751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A080EC9-2D55-E5D1-5C14-F644C9D50D18}"/>
              </a:ext>
            </a:extLst>
          </p:cNvPr>
          <p:cNvSpPr txBox="1"/>
          <p:nvPr/>
        </p:nvSpPr>
        <p:spPr>
          <a:xfrm>
            <a:off x="2386312" y="652019"/>
            <a:ext cx="10744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min) 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8554C60F-CC8C-8CEB-E42C-F5785E4C225C}"/>
              </a:ext>
            </a:extLst>
          </p:cNvPr>
          <p:cNvCxnSpPr/>
          <p:nvPr/>
        </p:nvCxnSpPr>
        <p:spPr>
          <a:xfrm>
            <a:off x="617654" y="1029745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76AB36C5-10AA-867F-ACD5-C3707CDE1198}"/>
              </a:ext>
            </a:extLst>
          </p:cNvPr>
          <p:cNvCxnSpPr/>
          <p:nvPr/>
        </p:nvCxnSpPr>
        <p:spPr>
          <a:xfrm>
            <a:off x="617654" y="1428729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F5DB72A-4E8D-FDD2-A17B-3F2DE65B0894}"/>
              </a:ext>
            </a:extLst>
          </p:cNvPr>
          <p:cNvCxnSpPr/>
          <p:nvPr/>
        </p:nvCxnSpPr>
        <p:spPr>
          <a:xfrm>
            <a:off x="617654" y="1740852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CC06BE3-3554-46FA-4EAB-E85832FA9B33}"/>
              </a:ext>
            </a:extLst>
          </p:cNvPr>
          <p:cNvCxnSpPr>
            <a:cxnSpLocks/>
          </p:cNvCxnSpPr>
          <p:nvPr/>
        </p:nvCxnSpPr>
        <p:spPr>
          <a:xfrm>
            <a:off x="799476" y="666821"/>
            <a:ext cx="6721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4AC9BC33-5C87-B4C3-6815-5FCE51567D3B}"/>
              </a:ext>
            </a:extLst>
          </p:cNvPr>
          <p:cNvCxnSpPr>
            <a:cxnSpLocks/>
          </p:cNvCxnSpPr>
          <p:nvPr/>
        </p:nvCxnSpPr>
        <p:spPr>
          <a:xfrm>
            <a:off x="1622253" y="669078"/>
            <a:ext cx="6721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E6E2B396-2E49-B524-59D6-346F7F55A53E}"/>
              </a:ext>
            </a:extLst>
          </p:cNvPr>
          <p:cNvSpPr txBox="1"/>
          <p:nvPr/>
        </p:nvSpPr>
        <p:spPr>
          <a:xfrm>
            <a:off x="385991" y="35589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9D7EB192-B64E-1764-EF8C-AD2F8507E4A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7" t="304" r="392" b="411"/>
          <a:stretch/>
        </p:blipFill>
        <p:spPr>
          <a:xfrm rot="16200000">
            <a:off x="4163538" y="-561064"/>
            <a:ext cx="3365617" cy="46407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A101B769-94A3-FFD2-1D36-F3F4FB69337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" t="294" r="-5" b="146"/>
          <a:stretch/>
        </p:blipFill>
        <p:spPr>
          <a:xfrm rot="16200000">
            <a:off x="814755" y="2760981"/>
            <a:ext cx="3374292" cy="46667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FB7A6399-890A-7FAA-C140-FF17EA5E27C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5" t="649" r="-104" b="578"/>
          <a:stretch/>
        </p:blipFill>
        <p:spPr>
          <a:xfrm rot="16200000">
            <a:off x="5624682" y="2795677"/>
            <a:ext cx="3225096" cy="45973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C9566908-7E48-583B-289E-03D77874A3E2}"/>
              </a:ext>
            </a:extLst>
          </p:cNvPr>
          <p:cNvSpPr/>
          <p:nvPr/>
        </p:nvSpPr>
        <p:spPr>
          <a:xfrm>
            <a:off x="4353865" y="2375728"/>
            <a:ext cx="1169365" cy="205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550EE24C-2A2F-B461-8F32-737DB38EE9C4}"/>
              </a:ext>
            </a:extLst>
          </p:cNvPr>
          <p:cNvSpPr/>
          <p:nvPr/>
        </p:nvSpPr>
        <p:spPr>
          <a:xfrm>
            <a:off x="2659905" y="5674310"/>
            <a:ext cx="1169365" cy="205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7E9A4607-120D-9D54-5F94-8A05A2BEBC62}"/>
              </a:ext>
            </a:extLst>
          </p:cNvPr>
          <p:cNvSpPr/>
          <p:nvPr/>
        </p:nvSpPr>
        <p:spPr>
          <a:xfrm>
            <a:off x="5846346" y="6055310"/>
            <a:ext cx="1169365" cy="205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B245A11-4134-2845-5612-3F84167271DE}"/>
              </a:ext>
            </a:extLst>
          </p:cNvPr>
          <p:cNvSpPr txBox="1"/>
          <p:nvPr/>
        </p:nvSpPr>
        <p:spPr>
          <a:xfrm>
            <a:off x="5523230" y="2367300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0C2B601-15E5-B642-28D3-73478A850850}"/>
              </a:ext>
            </a:extLst>
          </p:cNvPr>
          <p:cNvSpPr txBox="1"/>
          <p:nvPr/>
        </p:nvSpPr>
        <p:spPr>
          <a:xfrm>
            <a:off x="3895226" y="5649218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4BFDF32-3252-83F0-43E9-EE5F6066C04B}"/>
              </a:ext>
            </a:extLst>
          </p:cNvPr>
          <p:cNvSpPr txBox="1"/>
          <p:nvPr/>
        </p:nvSpPr>
        <p:spPr>
          <a:xfrm>
            <a:off x="5000717" y="6030218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</p:spTree>
    <p:extLst>
      <p:ext uri="{BB962C8B-B14F-4D97-AF65-F5344CB8AC3E}">
        <p14:creationId xmlns:p14="http://schemas.microsoft.com/office/powerpoint/2010/main" val="23996759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A7089D2-DD70-D9A9-A0C4-B31165BE9B6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3" t="21839" r="78327" b="54012"/>
          <a:stretch/>
        </p:blipFill>
        <p:spPr>
          <a:xfrm rot="5400000">
            <a:off x="1336045" y="538401"/>
            <a:ext cx="458182" cy="19636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56F9E7D-015D-4923-2F96-C17234278B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45" t="27502" r="40668" b="27011"/>
          <a:stretch/>
        </p:blipFill>
        <p:spPr>
          <a:xfrm rot="5400000">
            <a:off x="1336045" y="52048"/>
            <a:ext cx="458182" cy="19636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81CEDF0-FFB3-A950-43CE-176A8404A431}"/>
              </a:ext>
            </a:extLst>
          </p:cNvPr>
          <p:cNvSpPr txBox="1"/>
          <p:nvPr/>
        </p:nvSpPr>
        <p:spPr>
          <a:xfrm>
            <a:off x="2543982" y="836688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62F2C6E-F797-A8F9-4A11-2C715E5DEB65}"/>
              </a:ext>
            </a:extLst>
          </p:cNvPr>
          <p:cNvSpPr txBox="1"/>
          <p:nvPr/>
        </p:nvSpPr>
        <p:spPr>
          <a:xfrm>
            <a:off x="2551074" y="1419664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CCEBC75-8126-111E-1682-3BE1DFD393D5}"/>
              </a:ext>
            </a:extLst>
          </p:cNvPr>
          <p:cNvSpPr txBox="1"/>
          <p:nvPr/>
        </p:nvSpPr>
        <p:spPr>
          <a:xfrm>
            <a:off x="2543982" y="2278953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7A10F21-D2A3-AD40-5974-F76776E81EDE}"/>
              </a:ext>
            </a:extLst>
          </p:cNvPr>
          <p:cNvSpPr txBox="1"/>
          <p:nvPr/>
        </p:nvSpPr>
        <p:spPr>
          <a:xfrm>
            <a:off x="2487275" y="1089462"/>
            <a:ext cx="287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40CBC4-973B-6D3D-751C-C4AC208E2BBD}"/>
              </a:ext>
            </a:extLst>
          </p:cNvPr>
          <p:cNvSpPr txBox="1"/>
          <p:nvPr/>
        </p:nvSpPr>
        <p:spPr>
          <a:xfrm>
            <a:off x="612445" y="571339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E5D86BB-1BDA-28AC-3487-25746EF55198}"/>
              </a:ext>
            </a:extLst>
          </p:cNvPr>
          <p:cNvSpPr txBox="1"/>
          <p:nvPr/>
        </p:nvSpPr>
        <p:spPr>
          <a:xfrm>
            <a:off x="797721" y="571339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012754-9DED-C8D5-C8C3-1BD958B99F3B}"/>
              </a:ext>
            </a:extLst>
          </p:cNvPr>
          <p:cNvSpPr txBox="1"/>
          <p:nvPr/>
        </p:nvSpPr>
        <p:spPr>
          <a:xfrm>
            <a:off x="1042745" y="571339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AF22599-7481-5D71-6926-869DEDA698BE}"/>
              </a:ext>
            </a:extLst>
          </p:cNvPr>
          <p:cNvSpPr txBox="1"/>
          <p:nvPr/>
        </p:nvSpPr>
        <p:spPr>
          <a:xfrm>
            <a:off x="1287768" y="571339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577BC5F-5945-81F6-0806-36164A5F2418}"/>
              </a:ext>
            </a:extLst>
          </p:cNvPr>
          <p:cNvSpPr txBox="1"/>
          <p:nvPr/>
        </p:nvSpPr>
        <p:spPr>
          <a:xfrm>
            <a:off x="1532792" y="571339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171D751-9ED5-0F4B-8D78-B1B0DDAA11F5}"/>
              </a:ext>
            </a:extLst>
          </p:cNvPr>
          <p:cNvSpPr txBox="1"/>
          <p:nvPr/>
        </p:nvSpPr>
        <p:spPr>
          <a:xfrm>
            <a:off x="1718068" y="571339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1E0CE95-5917-3250-5657-39BF8EABE800}"/>
              </a:ext>
            </a:extLst>
          </p:cNvPr>
          <p:cNvSpPr txBox="1"/>
          <p:nvPr/>
        </p:nvSpPr>
        <p:spPr>
          <a:xfrm>
            <a:off x="1963092" y="571339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F35154E-1C8E-CECA-9C6A-4E73D0FA705A}"/>
              </a:ext>
            </a:extLst>
          </p:cNvPr>
          <p:cNvSpPr txBox="1"/>
          <p:nvPr/>
        </p:nvSpPr>
        <p:spPr>
          <a:xfrm>
            <a:off x="2208116" y="571339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96C6A0D-E75A-BA73-D4F5-511048D764FB}"/>
              </a:ext>
            </a:extLst>
          </p:cNvPr>
          <p:cNvSpPr txBox="1"/>
          <p:nvPr/>
        </p:nvSpPr>
        <p:spPr>
          <a:xfrm>
            <a:off x="2492570" y="571338"/>
            <a:ext cx="84350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(min)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C17D11B-30F1-35B1-87EC-34E71C958619}"/>
              </a:ext>
            </a:extLst>
          </p:cNvPr>
          <p:cNvSpPr txBox="1"/>
          <p:nvPr/>
        </p:nvSpPr>
        <p:spPr>
          <a:xfrm>
            <a:off x="758275" y="342634"/>
            <a:ext cx="663352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Cas9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4A5D636-477A-81A2-29A2-4B9D00AA4F8B}"/>
              </a:ext>
            </a:extLst>
          </p:cNvPr>
          <p:cNvSpPr txBox="1"/>
          <p:nvPr/>
        </p:nvSpPr>
        <p:spPr>
          <a:xfrm>
            <a:off x="1582995" y="337903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F2EB97B-AE4E-FE0E-9DD0-3F411559EDC9}"/>
              </a:ext>
            </a:extLst>
          </p:cNvPr>
          <p:cNvCxnSpPr/>
          <p:nvPr/>
        </p:nvCxnSpPr>
        <p:spPr>
          <a:xfrm>
            <a:off x="748286" y="555515"/>
            <a:ext cx="72533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9A8022F-AC67-B8F0-F020-C3A130315255}"/>
              </a:ext>
            </a:extLst>
          </p:cNvPr>
          <p:cNvCxnSpPr/>
          <p:nvPr/>
        </p:nvCxnSpPr>
        <p:spPr>
          <a:xfrm>
            <a:off x="1692982" y="555515"/>
            <a:ext cx="72533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" name="Picture 20">
            <a:extLst>
              <a:ext uri="{FF2B5EF4-FFF2-40B4-BE49-F238E27FC236}">
                <a16:creationId xmlns:a16="http://schemas.microsoft.com/office/drawing/2014/main" id="{9B36DAC6-56E7-BE56-9B5C-DA5F046695C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43" t="66836" r="57884" b="8890"/>
          <a:stretch/>
        </p:blipFill>
        <p:spPr>
          <a:xfrm rot="5400000">
            <a:off x="1336045" y="1506011"/>
            <a:ext cx="458182" cy="19636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1F5E3C9C-72A0-4AB6-80E1-D3295DB33E0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51" t="24595" r="73970" b="25359"/>
          <a:stretch/>
        </p:blipFill>
        <p:spPr>
          <a:xfrm rot="5400000">
            <a:off x="1336045" y="1018896"/>
            <a:ext cx="458182" cy="19636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13A552B-5AEA-9944-76DE-50CD4F91A142}"/>
              </a:ext>
            </a:extLst>
          </p:cNvPr>
          <p:cNvSpPr txBox="1"/>
          <p:nvPr/>
        </p:nvSpPr>
        <p:spPr>
          <a:xfrm>
            <a:off x="2543982" y="1817356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1EC533B-3624-D491-44F3-241897624971}"/>
              </a:ext>
            </a:extLst>
          </p:cNvPr>
          <p:cNvSpPr txBox="1"/>
          <p:nvPr/>
        </p:nvSpPr>
        <p:spPr>
          <a:xfrm>
            <a:off x="166673" y="2334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F5D988F-4DB4-AEF7-1228-F01BDB7F91DB}"/>
              </a:ext>
            </a:extLst>
          </p:cNvPr>
          <p:cNvSpPr txBox="1"/>
          <p:nvPr/>
        </p:nvSpPr>
        <p:spPr>
          <a:xfrm>
            <a:off x="206784" y="529277"/>
            <a:ext cx="35440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731362-254A-2880-C9A9-8AAFA4A9766C}"/>
              </a:ext>
            </a:extLst>
          </p:cNvPr>
          <p:cNvSpPr txBox="1"/>
          <p:nvPr/>
        </p:nvSpPr>
        <p:spPr>
          <a:xfrm>
            <a:off x="191981" y="708803"/>
            <a:ext cx="342751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FC4B632-5755-18E3-EAC3-3D49A50913A0}"/>
              </a:ext>
            </a:extLst>
          </p:cNvPr>
          <p:cNvSpPr txBox="1"/>
          <p:nvPr/>
        </p:nvSpPr>
        <p:spPr>
          <a:xfrm>
            <a:off x="260944" y="1067827"/>
            <a:ext cx="213719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3FCDC5C-59E1-7AC5-B9AB-9F7C31775E41}"/>
              </a:ext>
            </a:extLst>
          </p:cNvPr>
          <p:cNvSpPr txBox="1"/>
          <p:nvPr/>
        </p:nvSpPr>
        <p:spPr>
          <a:xfrm>
            <a:off x="260944" y="1822047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A04470F-FD74-0A09-BFFE-9D1CB24A101E}"/>
              </a:ext>
            </a:extLst>
          </p:cNvPr>
          <p:cNvSpPr txBox="1"/>
          <p:nvPr/>
        </p:nvSpPr>
        <p:spPr>
          <a:xfrm>
            <a:off x="260944" y="2211240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08398CF-E2B5-7BD9-6A02-C5D976ACA614}"/>
              </a:ext>
            </a:extLst>
          </p:cNvPr>
          <p:cNvSpPr txBox="1"/>
          <p:nvPr/>
        </p:nvSpPr>
        <p:spPr>
          <a:xfrm>
            <a:off x="260944" y="1383552"/>
            <a:ext cx="213719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7377034-EF12-2F92-4042-3984DFA78300}"/>
              </a:ext>
            </a:extLst>
          </p:cNvPr>
          <p:cNvCxnSpPr/>
          <p:nvPr/>
        </p:nvCxnSpPr>
        <p:spPr>
          <a:xfrm>
            <a:off x="491198" y="815737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BC44E777-1D1F-AC11-6EE5-1AFCFDE7DE5A}"/>
              </a:ext>
            </a:extLst>
          </p:cNvPr>
          <p:cNvCxnSpPr/>
          <p:nvPr/>
        </p:nvCxnSpPr>
        <p:spPr>
          <a:xfrm>
            <a:off x="491198" y="1168120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FA957DFB-2EAB-2E39-E7EB-4FD16B2D877B}"/>
              </a:ext>
            </a:extLst>
          </p:cNvPr>
          <p:cNvCxnSpPr/>
          <p:nvPr/>
        </p:nvCxnSpPr>
        <p:spPr>
          <a:xfrm>
            <a:off x="491198" y="1484795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2EEE268E-131D-1EC1-07B6-8506589930E6}"/>
              </a:ext>
            </a:extLst>
          </p:cNvPr>
          <p:cNvCxnSpPr/>
          <p:nvPr/>
        </p:nvCxnSpPr>
        <p:spPr>
          <a:xfrm>
            <a:off x="491198" y="1924133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1DC87B20-8020-8F6B-6E6B-7FDDB4ADAEEC}"/>
              </a:ext>
            </a:extLst>
          </p:cNvPr>
          <p:cNvCxnSpPr/>
          <p:nvPr/>
        </p:nvCxnSpPr>
        <p:spPr>
          <a:xfrm>
            <a:off x="491198" y="2321779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A496B55D-BDE4-8C85-DC68-0EC4BFBD279D}"/>
              </a:ext>
            </a:extLst>
          </p:cNvPr>
          <p:cNvSpPr txBox="1"/>
          <p:nvPr/>
        </p:nvSpPr>
        <p:spPr>
          <a:xfrm>
            <a:off x="260944" y="2459012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67DEF71-1760-A925-3B28-7580ABA0F5B8}"/>
              </a:ext>
            </a:extLst>
          </p:cNvPr>
          <p:cNvCxnSpPr/>
          <p:nvPr/>
        </p:nvCxnSpPr>
        <p:spPr>
          <a:xfrm>
            <a:off x="491198" y="2569551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55D7DD40-9DE0-9C57-91FE-3C000D6FC316}"/>
              </a:ext>
            </a:extLst>
          </p:cNvPr>
          <p:cNvSpPr txBox="1"/>
          <p:nvPr/>
        </p:nvSpPr>
        <p:spPr>
          <a:xfrm>
            <a:off x="491198" y="2705297"/>
            <a:ext cx="16145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 - nuclear fraction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61C07E11-D67C-95DC-14D1-188F93D32BC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" t="822" r="1766" b="-2451"/>
          <a:stretch/>
        </p:blipFill>
        <p:spPr>
          <a:xfrm rot="5400000">
            <a:off x="3043203" y="796601"/>
            <a:ext cx="3622574" cy="22513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D020102-1F65-926B-77D6-2503663C54A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9" t="-1024" r="519" b="295"/>
          <a:stretch/>
        </p:blipFill>
        <p:spPr>
          <a:xfrm rot="5400000">
            <a:off x="6524034" y="-389414"/>
            <a:ext cx="3697745" cy="46233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A58F132D-38C4-132E-5610-A8D3889FE6C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1" t="-12" r="-844" b="1458"/>
          <a:stretch/>
        </p:blipFill>
        <p:spPr>
          <a:xfrm rot="5400000">
            <a:off x="-266635" y="3664763"/>
            <a:ext cx="3566195" cy="26411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765F15BF-CBA5-5C6E-5F9F-8151C74987E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" t="514" r="1402" b="-206"/>
          <a:stretch/>
        </p:blipFill>
        <p:spPr>
          <a:xfrm rot="5400000">
            <a:off x="3640944" y="2709247"/>
            <a:ext cx="3355248" cy="4552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AD4D52EE-AA06-65BF-A419-B84701FC4E5E}"/>
              </a:ext>
            </a:extLst>
          </p:cNvPr>
          <p:cNvSpPr/>
          <p:nvPr/>
        </p:nvSpPr>
        <p:spPr>
          <a:xfrm>
            <a:off x="4344115" y="2025471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248D23F3-F10E-1077-9AFF-30410E1A0614}"/>
              </a:ext>
            </a:extLst>
          </p:cNvPr>
          <p:cNvSpPr/>
          <p:nvPr/>
        </p:nvSpPr>
        <p:spPr>
          <a:xfrm>
            <a:off x="8478653" y="611159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824627B4-7112-8B8C-A0BA-1A95C959E598}"/>
              </a:ext>
            </a:extLst>
          </p:cNvPr>
          <p:cNvSpPr/>
          <p:nvPr/>
        </p:nvSpPr>
        <p:spPr>
          <a:xfrm>
            <a:off x="838614" y="3782454"/>
            <a:ext cx="1329063" cy="3240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4C149D80-FC52-0768-3731-BF193B75150D}"/>
              </a:ext>
            </a:extLst>
          </p:cNvPr>
          <p:cNvSpPr/>
          <p:nvPr/>
        </p:nvSpPr>
        <p:spPr>
          <a:xfrm>
            <a:off x="3408289" y="4413370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965791-6223-DCDB-624A-6AEC5AF59F70}"/>
              </a:ext>
            </a:extLst>
          </p:cNvPr>
          <p:cNvSpPr txBox="1"/>
          <p:nvPr/>
        </p:nvSpPr>
        <p:spPr>
          <a:xfrm>
            <a:off x="5275580" y="2329082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59D4277-BC40-1FCC-B41F-3430F6AF7709}"/>
              </a:ext>
            </a:extLst>
          </p:cNvPr>
          <p:cNvSpPr txBox="1"/>
          <p:nvPr/>
        </p:nvSpPr>
        <p:spPr>
          <a:xfrm>
            <a:off x="9674914" y="824019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9E611B3-0AE4-013C-EE22-5105CA151914}"/>
              </a:ext>
            </a:extLst>
          </p:cNvPr>
          <p:cNvSpPr txBox="1"/>
          <p:nvPr/>
        </p:nvSpPr>
        <p:spPr>
          <a:xfrm>
            <a:off x="2283256" y="3960974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BA5E9CF-A695-A9E8-6FF0-C1356AC9A4CC}"/>
              </a:ext>
            </a:extLst>
          </p:cNvPr>
          <p:cNvSpPr txBox="1"/>
          <p:nvPr/>
        </p:nvSpPr>
        <p:spPr>
          <a:xfrm>
            <a:off x="3054665" y="4152176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</p:spTree>
    <p:extLst>
      <p:ext uri="{BB962C8B-B14F-4D97-AF65-F5344CB8AC3E}">
        <p14:creationId xmlns:p14="http://schemas.microsoft.com/office/powerpoint/2010/main" val="21755053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085E289-EB6D-1049-43CB-0FE2F08CA7B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64" t="21839" r="44226" b="54012"/>
          <a:stretch/>
        </p:blipFill>
        <p:spPr>
          <a:xfrm rot="5400000">
            <a:off x="1235196" y="487747"/>
            <a:ext cx="458182" cy="19636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6AAC93F-2653-3C1A-9CEA-64D5A8B052D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669" t="29527" r="23344" b="24986"/>
          <a:stretch/>
        </p:blipFill>
        <p:spPr>
          <a:xfrm rot="5400000">
            <a:off x="1235196" y="-5801"/>
            <a:ext cx="458182" cy="19636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98EE338-49C2-E096-041C-39325BEF7D9D}"/>
              </a:ext>
            </a:extLst>
          </p:cNvPr>
          <p:cNvSpPr txBox="1"/>
          <p:nvPr/>
        </p:nvSpPr>
        <p:spPr>
          <a:xfrm>
            <a:off x="2450782" y="807614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B810AF4-8205-8D51-8151-918E0D68EE64}"/>
              </a:ext>
            </a:extLst>
          </p:cNvPr>
          <p:cNvSpPr txBox="1"/>
          <p:nvPr/>
        </p:nvSpPr>
        <p:spPr>
          <a:xfrm>
            <a:off x="2450782" y="1401816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1DDC4B7-8296-5633-8BF7-0FD35774CFC7}"/>
              </a:ext>
            </a:extLst>
          </p:cNvPr>
          <p:cNvSpPr txBox="1"/>
          <p:nvPr/>
        </p:nvSpPr>
        <p:spPr>
          <a:xfrm>
            <a:off x="2413127" y="1004969"/>
            <a:ext cx="287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5D10E96-F0BC-A761-B85A-8B6B47DD7AF7}"/>
              </a:ext>
            </a:extLst>
          </p:cNvPr>
          <p:cNvSpPr txBox="1"/>
          <p:nvPr/>
        </p:nvSpPr>
        <p:spPr>
          <a:xfrm>
            <a:off x="519310" y="542265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8ACBFE-96AF-6ABC-6B85-3135C16F6C88}"/>
              </a:ext>
            </a:extLst>
          </p:cNvPr>
          <p:cNvSpPr txBox="1"/>
          <p:nvPr/>
        </p:nvSpPr>
        <p:spPr>
          <a:xfrm>
            <a:off x="704586" y="542265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0EF995C-61A6-8723-9246-DEE8B7C9D915}"/>
              </a:ext>
            </a:extLst>
          </p:cNvPr>
          <p:cNvSpPr txBox="1"/>
          <p:nvPr/>
        </p:nvSpPr>
        <p:spPr>
          <a:xfrm>
            <a:off x="949610" y="542265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59F97BB-3E91-E0AA-5A64-C6F9459B46F3}"/>
              </a:ext>
            </a:extLst>
          </p:cNvPr>
          <p:cNvSpPr txBox="1"/>
          <p:nvPr/>
        </p:nvSpPr>
        <p:spPr>
          <a:xfrm>
            <a:off x="1194634" y="542265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FE274D5-3337-5C87-138A-AE4A5FB0B591}"/>
              </a:ext>
            </a:extLst>
          </p:cNvPr>
          <p:cNvSpPr txBox="1"/>
          <p:nvPr/>
        </p:nvSpPr>
        <p:spPr>
          <a:xfrm>
            <a:off x="1439657" y="542265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DB693BB-7C08-95FA-CC6F-509F22D3DFE4}"/>
              </a:ext>
            </a:extLst>
          </p:cNvPr>
          <p:cNvSpPr txBox="1"/>
          <p:nvPr/>
        </p:nvSpPr>
        <p:spPr>
          <a:xfrm>
            <a:off x="1624934" y="542265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D3A750D-245C-2C15-17B7-D27E58F457DA}"/>
              </a:ext>
            </a:extLst>
          </p:cNvPr>
          <p:cNvSpPr txBox="1"/>
          <p:nvPr/>
        </p:nvSpPr>
        <p:spPr>
          <a:xfrm>
            <a:off x="1869957" y="542265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10EFADF-4586-C64C-9A5A-28DAF3363761}"/>
              </a:ext>
            </a:extLst>
          </p:cNvPr>
          <p:cNvSpPr txBox="1"/>
          <p:nvPr/>
        </p:nvSpPr>
        <p:spPr>
          <a:xfrm>
            <a:off x="2114982" y="542265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79B174F-CD9E-562D-C8F6-DA19541F5EB7}"/>
              </a:ext>
            </a:extLst>
          </p:cNvPr>
          <p:cNvSpPr txBox="1"/>
          <p:nvPr/>
        </p:nvSpPr>
        <p:spPr>
          <a:xfrm>
            <a:off x="2447861" y="542264"/>
            <a:ext cx="84350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(min)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7C67848-8704-46F6-DF1A-9767BEF11418}"/>
              </a:ext>
            </a:extLst>
          </p:cNvPr>
          <p:cNvSpPr txBox="1"/>
          <p:nvPr/>
        </p:nvSpPr>
        <p:spPr>
          <a:xfrm>
            <a:off x="665141" y="313559"/>
            <a:ext cx="663352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Cas9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7340992-EF95-133F-189A-827000208B20}"/>
              </a:ext>
            </a:extLst>
          </p:cNvPr>
          <p:cNvSpPr txBox="1"/>
          <p:nvPr/>
        </p:nvSpPr>
        <p:spPr>
          <a:xfrm>
            <a:off x="1588920" y="308828"/>
            <a:ext cx="7489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OE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E34A6ED-03B3-7BC5-281D-582DAD907C2E}"/>
              </a:ext>
            </a:extLst>
          </p:cNvPr>
          <p:cNvCxnSpPr/>
          <p:nvPr/>
        </p:nvCxnSpPr>
        <p:spPr>
          <a:xfrm>
            <a:off x="655152" y="526440"/>
            <a:ext cx="72533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8FD87EE-9C47-497F-3584-AA0ABCD30288}"/>
              </a:ext>
            </a:extLst>
          </p:cNvPr>
          <p:cNvCxnSpPr/>
          <p:nvPr/>
        </p:nvCxnSpPr>
        <p:spPr>
          <a:xfrm>
            <a:off x="1599847" y="526440"/>
            <a:ext cx="72533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0" name="Picture 19">
            <a:extLst>
              <a:ext uri="{FF2B5EF4-FFF2-40B4-BE49-F238E27FC236}">
                <a16:creationId xmlns:a16="http://schemas.microsoft.com/office/drawing/2014/main" id="{3B5BC069-D4AB-7B37-710B-661DCE1D1FC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813" t="67294" r="21614" b="8432"/>
          <a:stretch/>
        </p:blipFill>
        <p:spPr>
          <a:xfrm rot="5400000">
            <a:off x="1235196" y="1476689"/>
            <a:ext cx="458182" cy="19636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EF82E69A-AD90-DF05-C506-3CFA84EEE5E6}"/>
              </a:ext>
            </a:extLst>
          </p:cNvPr>
          <p:cNvSpPr txBox="1"/>
          <p:nvPr/>
        </p:nvSpPr>
        <p:spPr>
          <a:xfrm>
            <a:off x="2441502" y="2338039"/>
            <a:ext cx="9156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BF653EC9-0CAF-4EE0-7AD7-37BE216AE94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65" t="23256" r="56856" b="26698"/>
          <a:stretch/>
        </p:blipFill>
        <p:spPr>
          <a:xfrm rot="5400000">
            <a:off x="1235196" y="981318"/>
            <a:ext cx="458182" cy="19636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92BCDF3-7C43-3C77-97F3-F9442943E647}"/>
              </a:ext>
            </a:extLst>
          </p:cNvPr>
          <p:cNvSpPr txBox="1"/>
          <p:nvPr/>
        </p:nvSpPr>
        <p:spPr>
          <a:xfrm>
            <a:off x="2441502" y="1791385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77816FC-00D8-2A51-E016-A415C0CBA387}"/>
              </a:ext>
            </a:extLst>
          </p:cNvPr>
          <p:cNvSpPr txBox="1"/>
          <p:nvPr/>
        </p:nvSpPr>
        <p:spPr>
          <a:xfrm>
            <a:off x="0" y="1953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8635614-A8F3-EE6F-6A61-B0B896A98EDD}"/>
              </a:ext>
            </a:extLst>
          </p:cNvPr>
          <p:cNvSpPr txBox="1"/>
          <p:nvPr/>
        </p:nvSpPr>
        <p:spPr>
          <a:xfrm>
            <a:off x="104506" y="475663"/>
            <a:ext cx="35440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4D25633-4DF3-C3AD-F381-0A7720556C6A}"/>
              </a:ext>
            </a:extLst>
          </p:cNvPr>
          <p:cNvSpPr txBox="1"/>
          <p:nvPr/>
        </p:nvSpPr>
        <p:spPr>
          <a:xfrm>
            <a:off x="89704" y="655188"/>
            <a:ext cx="342751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65CF440-3F79-A4DA-6FBA-8F282F4CE68A}"/>
              </a:ext>
            </a:extLst>
          </p:cNvPr>
          <p:cNvSpPr txBox="1"/>
          <p:nvPr/>
        </p:nvSpPr>
        <p:spPr>
          <a:xfrm>
            <a:off x="158666" y="1014213"/>
            <a:ext cx="213719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C64D2AC-CD74-2890-63E7-87633379FA4C}"/>
              </a:ext>
            </a:extLst>
          </p:cNvPr>
          <p:cNvSpPr txBox="1"/>
          <p:nvPr/>
        </p:nvSpPr>
        <p:spPr>
          <a:xfrm>
            <a:off x="158666" y="1768432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F0E7D32-5191-E126-BC2C-A5C4A12D7A8D}"/>
              </a:ext>
            </a:extLst>
          </p:cNvPr>
          <p:cNvSpPr txBox="1"/>
          <p:nvPr/>
        </p:nvSpPr>
        <p:spPr>
          <a:xfrm>
            <a:off x="158666" y="2222193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55D2D74-F708-ED3B-7D0A-EFF839F432E8}"/>
              </a:ext>
            </a:extLst>
          </p:cNvPr>
          <p:cNvSpPr txBox="1"/>
          <p:nvPr/>
        </p:nvSpPr>
        <p:spPr>
          <a:xfrm>
            <a:off x="158666" y="1370292"/>
            <a:ext cx="213719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EF2A0B3D-EA6C-2422-6BD9-9ED9F8AA4A55}"/>
              </a:ext>
            </a:extLst>
          </p:cNvPr>
          <p:cNvCxnSpPr/>
          <p:nvPr/>
        </p:nvCxnSpPr>
        <p:spPr>
          <a:xfrm>
            <a:off x="388921" y="762123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25EF0892-575D-C269-6C80-9357A3CDADE3}"/>
              </a:ext>
            </a:extLst>
          </p:cNvPr>
          <p:cNvCxnSpPr/>
          <p:nvPr/>
        </p:nvCxnSpPr>
        <p:spPr>
          <a:xfrm>
            <a:off x="388921" y="1114506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065A5850-180C-253D-3B43-ADC7AE717132}"/>
              </a:ext>
            </a:extLst>
          </p:cNvPr>
          <p:cNvCxnSpPr/>
          <p:nvPr/>
        </p:nvCxnSpPr>
        <p:spPr>
          <a:xfrm>
            <a:off x="388921" y="1471535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16EE218-4E49-C234-06FA-BA1F98DF3E8F}"/>
              </a:ext>
            </a:extLst>
          </p:cNvPr>
          <p:cNvCxnSpPr/>
          <p:nvPr/>
        </p:nvCxnSpPr>
        <p:spPr>
          <a:xfrm>
            <a:off x="388921" y="1870518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27FE3708-DBBF-F7A8-25AD-3950662679BA}"/>
              </a:ext>
            </a:extLst>
          </p:cNvPr>
          <p:cNvCxnSpPr/>
          <p:nvPr/>
        </p:nvCxnSpPr>
        <p:spPr>
          <a:xfrm>
            <a:off x="388921" y="2332732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5E01BBF-9D04-C215-D77F-D1C6FB177C2D}"/>
              </a:ext>
            </a:extLst>
          </p:cNvPr>
          <p:cNvSpPr txBox="1"/>
          <p:nvPr/>
        </p:nvSpPr>
        <p:spPr>
          <a:xfrm>
            <a:off x="160601" y="2469965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A87C8703-EFB7-8ADC-9562-9F8A06960A1D}"/>
              </a:ext>
            </a:extLst>
          </p:cNvPr>
          <p:cNvCxnSpPr/>
          <p:nvPr/>
        </p:nvCxnSpPr>
        <p:spPr>
          <a:xfrm>
            <a:off x="388921" y="2580504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24C6B944-732B-BDDC-787E-9CFF72AB8A9C}"/>
              </a:ext>
            </a:extLst>
          </p:cNvPr>
          <p:cNvSpPr txBox="1"/>
          <p:nvPr/>
        </p:nvSpPr>
        <p:spPr>
          <a:xfrm>
            <a:off x="386228" y="2694617"/>
            <a:ext cx="16145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 - nuclear fraction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E6721D11-C90D-BE14-7B88-9C8BBD45FAC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2" t="1527" r="1312" b="-290"/>
          <a:stretch/>
        </p:blipFill>
        <p:spPr>
          <a:xfrm rot="5400000">
            <a:off x="2916163" y="759814"/>
            <a:ext cx="3656099" cy="24066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A910A05-46CE-DDEF-DE8A-B461F6AC22E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7" t="653" r="891" b="287"/>
          <a:stretch/>
        </p:blipFill>
        <p:spPr>
          <a:xfrm rot="5400000">
            <a:off x="6486817" y="-310277"/>
            <a:ext cx="3685703" cy="45468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7EABD67-FF14-FF13-8619-28FD4845A62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" t="-88" r="1037" b="1454"/>
          <a:stretch/>
        </p:blipFill>
        <p:spPr>
          <a:xfrm rot="5400000">
            <a:off x="-142822" y="4237358"/>
            <a:ext cx="2899995" cy="21845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BDB7C4A4-D3BF-1AF6-5AAA-3E45715CD6E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7" t="353" r="546" b="584"/>
          <a:stretch/>
        </p:blipFill>
        <p:spPr>
          <a:xfrm rot="5400000">
            <a:off x="3130319" y="2787697"/>
            <a:ext cx="3376515" cy="45235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D0A52054-7724-B434-B858-D755266A666D}"/>
              </a:ext>
            </a:extLst>
          </p:cNvPr>
          <p:cNvSpPr/>
          <p:nvPr/>
        </p:nvSpPr>
        <p:spPr>
          <a:xfrm>
            <a:off x="4159529" y="2701949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A979AAAE-EFBF-E061-1290-D45ADCA42EC5}"/>
              </a:ext>
            </a:extLst>
          </p:cNvPr>
          <p:cNvSpPr/>
          <p:nvPr/>
        </p:nvSpPr>
        <p:spPr>
          <a:xfrm>
            <a:off x="8460616" y="1963134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2DE99AD5-CD57-1160-FD61-994FE0BD728F}"/>
              </a:ext>
            </a:extLst>
          </p:cNvPr>
          <p:cNvSpPr/>
          <p:nvPr/>
        </p:nvSpPr>
        <p:spPr>
          <a:xfrm>
            <a:off x="722492" y="4898847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05588C5C-56B0-580D-D18F-87E7499583A9}"/>
              </a:ext>
            </a:extLst>
          </p:cNvPr>
          <p:cNvSpPr/>
          <p:nvPr/>
        </p:nvSpPr>
        <p:spPr>
          <a:xfrm>
            <a:off x="2856245" y="5767633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717BA0D-2CCE-028C-C502-A0C382603F40}"/>
              </a:ext>
            </a:extLst>
          </p:cNvPr>
          <p:cNvSpPr txBox="1"/>
          <p:nvPr/>
        </p:nvSpPr>
        <p:spPr>
          <a:xfrm>
            <a:off x="5328973" y="2898249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CF325DE-0AB4-8252-47F4-5ABA3C7843F9}"/>
              </a:ext>
            </a:extLst>
          </p:cNvPr>
          <p:cNvSpPr txBox="1"/>
          <p:nvPr/>
        </p:nvSpPr>
        <p:spPr>
          <a:xfrm>
            <a:off x="9625136" y="2133539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C33EB09-B447-BAE5-A5E7-F0285992D368}"/>
              </a:ext>
            </a:extLst>
          </p:cNvPr>
          <p:cNvSpPr txBox="1"/>
          <p:nvPr/>
        </p:nvSpPr>
        <p:spPr>
          <a:xfrm>
            <a:off x="169201" y="4986235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2B0BD88-2F88-9C3F-920D-1A9891BCA18C}"/>
              </a:ext>
            </a:extLst>
          </p:cNvPr>
          <p:cNvSpPr txBox="1"/>
          <p:nvPr/>
        </p:nvSpPr>
        <p:spPr>
          <a:xfrm>
            <a:off x="2869611" y="6088375"/>
            <a:ext cx="9156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</p:spTree>
    <p:extLst>
      <p:ext uri="{BB962C8B-B14F-4D97-AF65-F5344CB8AC3E}">
        <p14:creationId xmlns:p14="http://schemas.microsoft.com/office/powerpoint/2010/main" val="30850138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D4C1E0F-0AB3-3CA8-DE5C-D76542986D57}"/>
              </a:ext>
            </a:extLst>
          </p:cNvPr>
          <p:cNvSpPr txBox="1"/>
          <p:nvPr/>
        </p:nvSpPr>
        <p:spPr>
          <a:xfrm>
            <a:off x="2808554" y="86254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EAAAAD3-305C-29C4-9169-B46021C3083B}"/>
              </a:ext>
            </a:extLst>
          </p:cNvPr>
          <p:cNvSpPr txBox="1"/>
          <p:nvPr/>
        </p:nvSpPr>
        <p:spPr>
          <a:xfrm>
            <a:off x="2808555" y="1523797"/>
            <a:ext cx="7601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0225B94-B21B-61E3-09B7-A5374683666D}"/>
              </a:ext>
            </a:extLst>
          </p:cNvPr>
          <p:cNvSpPr txBox="1"/>
          <p:nvPr/>
        </p:nvSpPr>
        <p:spPr>
          <a:xfrm>
            <a:off x="2808554" y="1965744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C00673-D702-C820-C50C-F5FB68E8B86F}"/>
              </a:ext>
            </a:extLst>
          </p:cNvPr>
          <p:cNvSpPr txBox="1"/>
          <p:nvPr/>
        </p:nvSpPr>
        <p:spPr>
          <a:xfrm>
            <a:off x="2751543" y="1049153"/>
            <a:ext cx="316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581AAFF-0454-2DC0-0EF4-5F1FC27A25B2}"/>
              </a:ext>
            </a:extLst>
          </p:cNvPr>
          <p:cNvSpPr txBox="1"/>
          <p:nvPr/>
        </p:nvSpPr>
        <p:spPr>
          <a:xfrm>
            <a:off x="675057" y="52493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07F6636-AD45-02E3-1068-741E09F8F3FA}"/>
              </a:ext>
            </a:extLst>
          </p:cNvPr>
          <p:cNvSpPr txBox="1"/>
          <p:nvPr/>
        </p:nvSpPr>
        <p:spPr>
          <a:xfrm>
            <a:off x="878861" y="52493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0FA6E19-D92F-71FC-EACE-238002CF287F}"/>
              </a:ext>
            </a:extLst>
          </p:cNvPr>
          <p:cNvSpPr txBox="1"/>
          <p:nvPr/>
        </p:nvSpPr>
        <p:spPr>
          <a:xfrm>
            <a:off x="1148387" y="52493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75BEA8B-C6F2-0677-ADC6-BDDAD3A7E3D3}"/>
              </a:ext>
            </a:extLst>
          </p:cNvPr>
          <p:cNvSpPr txBox="1"/>
          <p:nvPr/>
        </p:nvSpPr>
        <p:spPr>
          <a:xfrm>
            <a:off x="1417913" y="52493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9F707A6-CECD-44AA-585D-2B4493465C28}"/>
              </a:ext>
            </a:extLst>
          </p:cNvPr>
          <p:cNvSpPr txBox="1"/>
          <p:nvPr/>
        </p:nvSpPr>
        <p:spPr>
          <a:xfrm>
            <a:off x="1687439" y="52493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DCE3130-9CA6-9140-61EF-24F0C312DC37}"/>
              </a:ext>
            </a:extLst>
          </p:cNvPr>
          <p:cNvSpPr txBox="1"/>
          <p:nvPr/>
        </p:nvSpPr>
        <p:spPr>
          <a:xfrm>
            <a:off x="1891243" y="52493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BD78D09-3F3E-75E8-ABED-478B70D2E6C6}"/>
              </a:ext>
            </a:extLst>
          </p:cNvPr>
          <p:cNvSpPr txBox="1"/>
          <p:nvPr/>
        </p:nvSpPr>
        <p:spPr>
          <a:xfrm>
            <a:off x="2160769" y="52493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18E22C-5B00-12D8-1ECF-8DE11BA9CD8B}"/>
              </a:ext>
            </a:extLst>
          </p:cNvPr>
          <p:cNvSpPr txBox="1"/>
          <p:nvPr/>
        </p:nvSpPr>
        <p:spPr>
          <a:xfrm>
            <a:off x="2430296" y="52493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D9756F3-B1C8-399B-2174-0BD2681D9A84}"/>
              </a:ext>
            </a:extLst>
          </p:cNvPr>
          <p:cNvSpPr txBox="1"/>
          <p:nvPr/>
        </p:nvSpPr>
        <p:spPr>
          <a:xfrm>
            <a:off x="2743195" y="524937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F3C0981-94F6-398C-B6DE-1A0E580D6747}"/>
              </a:ext>
            </a:extLst>
          </p:cNvPr>
          <p:cNvSpPr txBox="1"/>
          <p:nvPr/>
        </p:nvSpPr>
        <p:spPr>
          <a:xfrm>
            <a:off x="885763" y="273362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Cas9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E532E6C-8A63-3356-DD85-BF0B1AF0D5C8}"/>
              </a:ext>
            </a:extLst>
          </p:cNvPr>
          <p:cNvSpPr txBox="1"/>
          <p:nvPr/>
        </p:nvSpPr>
        <p:spPr>
          <a:xfrm>
            <a:off x="1677892" y="268158"/>
            <a:ext cx="12939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C110A+H668R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08D2E08-B82D-DA5C-A1B3-2CD383569332}"/>
              </a:ext>
            </a:extLst>
          </p:cNvPr>
          <p:cNvCxnSpPr/>
          <p:nvPr/>
        </p:nvCxnSpPr>
        <p:spPr>
          <a:xfrm>
            <a:off x="824483" y="507531"/>
            <a:ext cx="7978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2B920EF-9CE3-E86B-8FAC-B327B7F4A597}"/>
              </a:ext>
            </a:extLst>
          </p:cNvPr>
          <p:cNvCxnSpPr/>
          <p:nvPr/>
        </p:nvCxnSpPr>
        <p:spPr>
          <a:xfrm>
            <a:off x="1863648" y="507531"/>
            <a:ext cx="7978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9" name="Picture 18">
            <a:extLst>
              <a:ext uri="{FF2B5EF4-FFF2-40B4-BE49-F238E27FC236}">
                <a16:creationId xmlns:a16="http://schemas.microsoft.com/office/drawing/2014/main" id="{DE9163F4-B81E-163A-E51C-DBC02E371C9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28" t="19640" r="61881" b="55230"/>
          <a:stretch/>
        </p:blipFill>
        <p:spPr>
          <a:xfrm rot="5400000">
            <a:off x="1469107" y="490043"/>
            <a:ext cx="504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979C5F3-A634-44C5-2A20-89E62622ED5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606" t="19665" r="37003" b="55205"/>
          <a:stretch/>
        </p:blipFill>
        <p:spPr>
          <a:xfrm rot="5400000">
            <a:off x="1469107" y="1027374"/>
            <a:ext cx="504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2B09F38-0B88-1171-0DAC-965929BDB63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85" t="19629" r="33836" b="56311"/>
          <a:stretch/>
        </p:blipFill>
        <p:spPr>
          <a:xfrm rot="5400000">
            <a:off x="1469107" y="-48101"/>
            <a:ext cx="504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66CB5CD-7851-3BBB-278D-FCB60C1A0268}"/>
              </a:ext>
            </a:extLst>
          </p:cNvPr>
          <p:cNvSpPr txBox="1"/>
          <p:nvPr/>
        </p:nvSpPr>
        <p:spPr>
          <a:xfrm>
            <a:off x="280973" y="19393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B7847BE-294E-B9F7-84EA-E2CB523855FB}"/>
              </a:ext>
            </a:extLst>
          </p:cNvPr>
          <p:cNvSpPr txBox="1"/>
          <p:nvPr/>
        </p:nvSpPr>
        <p:spPr>
          <a:xfrm>
            <a:off x="240043" y="474275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25F1267-70A5-FB90-972B-98CE52B0989C}"/>
              </a:ext>
            </a:extLst>
          </p:cNvPr>
          <p:cNvSpPr txBox="1"/>
          <p:nvPr/>
        </p:nvSpPr>
        <p:spPr>
          <a:xfrm>
            <a:off x="251444" y="67175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D0610D8-EF56-5997-5E94-D9E636A53E33}"/>
              </a:ext>
            </a:extLst>
          </p:cNvPr>
          <p:cNvSpPr txBox="1"/>
          <p:nvPr/>
        </p:nvSpPr>
        <p:spPr>
          <a:xfrm>
            <a:off x="299619" y="1043820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83FD340-678A-A0DC-B08A-D1DC19FC74FA}"/>
              </a:ext>
            </a:extLst>
          </p:cNvPr>
          <p:cNvSpPr txBox="1"/>
          <p:nvPr/>
        </p:nvSpPr>
        <p:spPr>
          <a:xfrm>
            <a:off x="299619" y="153021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6DF9290-5350-C701-DC03-83058DE9E9F7}"/>
              </a:ext>
            </a:extLst>
          </p:cNvPr>
          <p:cNvSpPr txBox="1"/>
          <p:nvPr/>
        </p:nvSpPr>
        <p:spPr>
          <a:xfrm>
            <a:off x="297143" y="183707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C2F8084-D16F-BEEC-BCDA-6E0C3EE5A800}"/>
              </a:ext>
            </a:extLst>
          </p:cNvPr>
          <p:cNvCxnSpPr/>
          <p:nvPr/>
        </p:nvCxnSpPr>
        <p:spPr>
          <a:xfrm>
            <a:off x="552899" y="78938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46C4D99-EB21-58F8-EBCB-633A534E987C}"/>
              </a:ext>
            </a:extLst>
          </p:cNvPr>
          <p:cNvCxnSpPr/>
          <p:nvPr/>
        </p:nvCxnSpPr>
        <p:spPr>
          <a:xfrm>
            <a:off x="552899" y="1154142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26A74CF1-0D2E-541B-AC3A-205EB1F97DDB}"/>
              </a:ext>
            </a:extLst>
          </p:cNvPr>
          <p:cNvCxnSpPr/>
          <p:nvPr/>
        </p:nvCxnSpPr>
        <p:spPr>
          <a:xfrm>
            <a:off x="552899" y="164250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6678425-181F-98B4-964D-782A69976A94}"/>
              </a:ext>
            </a:extLst>
          </p:cNvPr>
          <p:cNvCxnSpPr/>
          <p:nvPr/>
        </p:nvCxnSpPr>
        <p:spPr>
          <a:xfrm>
            <a:off x="550423" y="195867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C3835F69-92EA-42FA-2172-41374E2E90D8}"/>
              </a:ext>
            </a:extLst>
          </p:cNvPr>
          <p:cNvSpPr txBox="1"/>
          <p:nvPr/>
        </p:nvSpPr>
        <p:spPr>
          <a:xfrm>
            <a:off x="297143" y="210962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4C8761A-8EA5-3733-0B19-19AEB66833F1}"/>
              </a:ext>
            </a:extLst>
          </p:cNvPr>
          <p:cNvCxnSpPr/>
          <p:nvPr/>
        </p:nvCxnSpPr>
        <p:spPr>
          <a:xfrm>
            <a:off x="550423" y="223122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3D200ED7-640E-95C8-A538-834734B921B3}"/>
              </a:ext>
            </a:extLst>
          </p:cNvPr>
          <p:cNvSpPr txBox="1"/>
          <p:nvPr/>
        </p:nvSpPr>
        <p:spPr>
          <a:xfrm>
            <a:off x="539589" y="2332733"/>
            <a:ext cx="16145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 - nuclear fraction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CA14361A-D4D5-AFA2-CC9E-A42A8F828FF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4" t="329" r="1419" b="80"/>
          <a:stretch/>
        </p:blipFill>
        <p:spPr>
          <a:xfrm rot="5400000">
            <a:off x="964877" y="2503653"/>
            <a:ext cx="3672459" cy="45880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0B74F999-C927-AA6D-7C8E-F2BA5726F04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" t="827" r="-210" b="-396"/>
          <a:stretch/>
        </p:blipFill>
        <p:spPr>
          <a:xfrm rot="5400000">
            <a:off x="6211945" y="2382221"/>
            <a:ext cx="3384563" cy="48309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Rectangle 36">
            <a:extLst>
              <a:ext uri="{FF2B5EF4-FFF2-40B4-BE49-F238E27FC236}">
                <a16:creationId xmlns:a16="http://schemas.microsoft.com/office/drawing/2014/main" id="{5F4E591D-48E6-0FAE-E3B7-EEA4F1AA380A}"/>
              </a:ext>
            </a:extLst>
          </p:cNvPr>
          <p:cNvSpPr/>
          <p:nvPr/>
        </p:nvSpPr>
        <p:spPr>
          <a:xfrm>
            <a:off x="3078501" y="5132791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76AF528-1201-8D97-A9DB-611BC88E1842}"/>
              </a:ext>
            </a:extLst>
          </p:cNvPr>
          <p:cNvSpPr/>
          <p:nvPr/>
        </p:nvSpPr>
        <p:spPr>
          <a:xfrm>
            <a:off x="8260101" y="4180291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0E7DB74-C669-A84C-852D-6462B4387F19}"/>
              </a:ext>
            </a:extLst>
          </p:cNvPr>
          <p:cNvSpPr/>
          <p:nvPr/>
        </p:nvSpPr>
        <p:spPr>
          <a:xfrm>
            <a:off x="8234700" y="4944079"/>
            <a:ext cx="1169365" cy="301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805B3D3-561E-1DF4-A104-0B5BF0657416}"/>
              </a:ext>
            </a:extLst>
          </p:cNvPr>
          <p:cNvSpPr txBox="1"/>
          <p:nvPr/>
        </p:nvSpPr>
        <p:spPr>
          <a:xfrm>
            <a:off x="3660542" y="5439703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D82F5EE-5C91-7FD5-233F-0F4903A1F66D}"/>
              </a:ext>
            </a:extLst>
          </p:cNvPr>
          <p:cNvSpPr txBox="1"/>
          <p:nvPr/>
        </p:nvSpPr>
        <p:spPr>
          <a:xfrm>
            <a:off x="8643921" y="4481515"/>
            <a:ext cx="7601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CFB7751-6B1A-312A-367C-BD2DB2C07339}"/>
              </a:ext>
            </a:extLst>
          </p:cNvPr>
          <p:cNvSpPr txBox="1"/>
          <p:nvPr/>
        </p:nvSpPr>
        <p:spPr>
          <a:xfrm>
            <a:off x="8643921" y="5254903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</p:spTree>
    <p:extLst>
      <p:ext uri="{BB962C8B-B14F-4D97-AF65-F5344CB8AC3E}">
        <p14:creationId xmlns:p14="http://schemas.microsoft.com/office/powerpoint/2010/main" val="692557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98</Words>
  <Application>Microsoft Office PowerPoint</Application>
  <PresentationFormat>Widescreen</PresentationFormat>
  <Paragraphs>13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5-10T10:27:57Z</dcterms:created>
  <dcterms:modified xsi:type="dcterms:W3CDTF">2024-05-10T10:51:35Z</dcterms:modified>
</cp:coreProperties>
</file>